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sldIdLst>
    <p:sldId id="25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73" d="100"/>
          <a:sy n="73" d="100"/>
        </p:scale>
        <p:origin x="380" y="5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1.xml"/><Relationship Id="rId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617C0B-4C22-EE5A-6DD4-25F13109C7A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17B5F92-972D-AE2E-2A25-BDB12D34102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D5C537-4136-E10A-DB56-9628D1871B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A1779-7C93-4221-A127-A52E5F7B08CB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54865C-661F-192E-528E-D4D7D8D274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6AEB68-7A10-6660-5AFE-C531A3BFFE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DE9D6-130D-410F-9DFD-7F1CBB799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9712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5437A9-57FE-7EE7-AE53-09F703E6F6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5A10D99-3BA4-6BEE-CD13-FCBF9546A0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EC4857-2B67-E660-C6ED-A6DBC781C8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A1779-7C93-4221-A127-A52E5F7B08CB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8A1BED-71AC-E8B4-87C3-F3C6762DAB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0DBEDA-A5BA-D561-A8BF-E542E9D428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DE9D6-130D-410F-9DFD-7F1CBB799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91677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2480EFA-6601-22FE-C5AE-CA21B203BB7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AC9525A-022E-B361-5452-4C09A9BDC36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DA3DA8-EC31-294F-1E05-F775CD58F7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A1779-7C93-4221-A127-A52E5F7B08CB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24F460-0FC5-3DC1-2439-820969D401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9C0E4E-F17F-CAB6-CDBC-DAC227998B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DE9D6-130D-410F-9DFD-7F1CBB799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44636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4"/>
            <a:ext cx="103632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8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2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0DA26-8BF3-4564-9A6F-1A4772032E1B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5499D-C868-4BDD-B63B-1D306DF53F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283992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0DA26-8BF3-4564-9A6F-1A4772032E1B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5499D-C868-4BDD-B63B-1D306DF53F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2895112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78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13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0DA26-8BF3-4564-9A6F-1A4772032E1B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5499D-C868-4BDD-B63B-1D306DF53F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5375689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0DA26-8BF3-4564-9A6F-1A4772032E1B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5499D-C868-4BDD-B63B-1D306DF53F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1756056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90" y="1681164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8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2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90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681164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8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2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0DA26-8BF3-4564-9A6F-1A4772032E1B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5499D-C868-4BDD-B63B-1D306DF53F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5546103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0DA26-8BF3-4564-9A6F-1A4772032E1B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5499D-C868-4BDD-B63B-1D306DF53F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022864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0DA26-8BF3-4564-9A6F-1A4772032E1B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5499D-C868-4BDD-B63B-1D306DF53F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6414621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8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2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0DA26-8BF3-4564-9A6F-1A4772032E1B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5499D-C868-4BDD-B63B-1D306DF53F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895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7C8E6A-855F-9779-5BAE-C1A6FE2B4C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20427A6-7531-FE7F-8BBF-01FB80B4222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5E92BC-F8D9-AA9D-1411-436F7EBEBD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A1779-7C93-4221-A127-A52E5F7B08CB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418A92-3B61-5CC7-C1EF-C31E8C1095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E102BB-0471-1DCB-0656-3833F582AB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DE9D6-130D-410F-9DFD-7F1CBB799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2475301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8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2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8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2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0DA26-8BF3-4564-9A6F-1A4772032E1B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5499D-C868-4BDD-B63B-1D306DF53F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8252748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0DA26-8BF3-4564-9A6F-1A4772032E1B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5499D-C868-4BDD-B63B-1D306DF53F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1436894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6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6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0DA26-8BF3-4564-9A6F-1A4772032E1B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5499D-C868-4BDD-B63B-1D306DF53F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51605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F53068-D454-91B5-0194-DFEC34479D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5262BA6-B3FB-30A3-2873-7120DD46A1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AEF128-03A0-7893-13EF-BDDD000151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A1779-7C93-4221-A127-A52E5F7B08CB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8E62D6-058B-68D3-8724-004F147920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59E523-056A-919A-4143-4E854D7999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DE9D6-130D-410F-9DFD-7F1CBB799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52650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7DADC6-042D-890F-3987-17D4E8B4DD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0D88412-6733-49F2-C0B7-57ACFAB8CCE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2637502-1E13-90C0-EB14-4EA1AB5210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86631B-2962-0992-6B51-D010BAF982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A1779-7C93-4221-A127-A52E5F7B08CB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8CB47C-92CC-CBB6-5AA5-93AB0D0207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BDE58D-A141-0596-5035-937852D574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DE9D6-130D-410F-9DFD-7F1CBB799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7077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7B6E98-0C3F-904F-E36B-1521D446CB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06E91B0-A936-D6CB-D3C4-8BE952ECE4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7148F2B-06D2-3A1C-31CD-70ED91611D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D4806B9-68F1-BF58-6803-A48055CE0B0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1AD675F-8CA5-F7C5-B18B-A8CDB9F115E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9EE418A-D2C7-4A2B-550D-761DAF5421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A1779-7C93-4221-A127-A52E5F7B08CB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32B589E-CA02-B80D-4405-60BC064695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0E677DE-9077-8850-D745-4D290C4E64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DE9D6-130D-410F-9DFD-7F1CBB799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84033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290B83-34B5-1C22-434F-8C867540EF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FF8194A-966F-7D20-96E5-225554C61A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A1779-7C93-4221-A127-A52E5F7B08CB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EE92265-3A77-A16E-8C0B-3D271C926A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2D23A76-7303-326A-142D-242B5113EF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DE9D6-130D-410F-9DFD-7F1CBB799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0415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9A27F7F-0790-6531-EB8C-7FDE1D3217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A1779-7C93-4221-A127-A52E5F7B08CB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3B4B972-655A-E9D8-7BB0-02ECAA50BE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9C04E22-E8D3-F404-E76E-1ED957DF43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DE9D6-130D-410F-9DFD-7F1CBB799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05643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E48E66-D13D-274D-FDB0-FEC4410DBA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BCDF46E-394A-A876-B3FE-7134132556B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362AF7C-420B-1D0C-F54F-1A5940AF03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350724B-322C-8CF2-0B7B-AD47C1D131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A1779-7C93-4221-A127-A52E5F7B08CB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6445C2-86F1-1AA3-AC34-1DD286ECCF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83BF35-AB3B-3762-2658-C286652085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DE9D6-130D-410F-9DFD-7F1CBB799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02860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7EA32C-8DE3-0FF1-AA31-33E4D5C69B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CA38523-20E3-EADD-CDCE-753F92BA6F1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11C42D4-401F-637D-2D7D-A040CCC2ED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1EC2D8-8F7D-2ECC-D944-1C143736F5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A1779-7C93-4221-A127-A52E5F7B08CB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5C196A-BFB0-AEEF-7076-69169639A8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097E969-D116-83B3-5A24-8727885E1A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DE9D6-130D-410F-9DFD-7F1CBB799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83998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7C4804B-20EA-711D-1CE5-2A22CB42D9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A27E03C-E6D0-3324-B11C-0D858ED585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03E834-8D00-5133-FF6A-1A0ABCFCF1E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5A1779-7C93-4221-A127-A52E5F7B08CB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A3F74F-2188-60C2-FE3E-90C7AA12720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1586C2-B75F-2475-0986-2BD29D728EA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1DE9D6-130D-410F-9DFD-7F1CBB799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54481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E0DA26-8BF3-4564-9A6F-1A4772032E1B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F5499D-C868-4BDD-B63B-1D306DF53F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7071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378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8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2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8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5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8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2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BF16FD-3778-09EE-8013-32F782A8DB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8509" y="6012351"/>
            <a:ext cx="12034982" cy="845649"/>
          </a:xfrm>
        </p:spPr>
        <p:txBody>
          <a:bodyPr>
            <a:no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 One-way analysis of variance of identified metabolites (n=394) among all phenotypic groups (planktonic cells under shaking (PLSH), planktonic cells under static conditions (PLST), and biofilm cells). Green and red-colored dots, represent metabolites with nonsignificant or significant difference among the three groups</a:t>
            </a:r>
            <a:r>
              <a:rPr 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, respectively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74" name="Picture 2">
            <a:extLst>
              <a:ext uri="{FF2B5EF4-FFF2-40B4-BE49-F238E27FC236}">
                <a16:creationId xmlns:a16="http://schemas.microsoft.com/office/drawing/2014/main" id="{108C0191-6C7D-9735-30BE-70272DB3F34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21" r="2023"/>
          <a:stretch/>
        </p:blipFill>
        <p:spPr bwMode="auto">
          <a:xfrm>
            <a:off x="1742502" y="753289"/>
            <a:ext cx="8107183" cy="53717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Flowchart: Connector 2">
            <a:extLst>
              <a:ext uri="{FF2B5EF4-FFF2-40B4-BE49-F238E27FC236}">
                <a16:creationId xmlns:a16="http://schemas.microsoft.com/office/drawing/2014/main" id="{2BBE67BF-F274-0F0A-05D0-E9D32E7C5D24}"/>
              </a:ext>
            </a:extLst>
          </p:cNvPr>
          <p:cNvSpPr/>
          <p:nvPr/>
        </p:nvSpPr>
        <p:spPr>
          <a:xfrm>
            <a:off x="10485480" y="279408"/>
            <a:ext cx="215003" cy="207945"/>
          </a:xfrm>
          <a:prstGeom prst="flowChartConnector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endParaRPr lang="en-US" sz="1200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5" name="Flowchart: Connector 4">
            <a:extLst>
              <a:ext uri="{FF2B5EF4-FFF2-40B4-BE49-F238E27FC236}">
                <a16:creationId xmlns:a16="http://schemas.microsoft.com/office/drawing/2014/main" id="{7165FDE2-EDA0-3201-6227-44BD8514D749}"/>
              </a:ext>
            </a:extLst>
          </p:cNvPr>
          <p:cNvSpPr/>
          <p:nvPr/>
        </p:nvSpPr>
        <p:spPr>
          <a:xfrm>
            <a:off x="10485507" y="610705"/>
            <a:ext cx="215003" cy="207945"/>
          </a:xfrm>
          <a:prstGeom prst="flowChartConnector">
            <a:avLst/>
          </a:prstGeom>
          <a:solidFill>
            <a:schemeClr val="accent6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endParaRPr lang="en-US" sz="1200">
              <a:solidFill>
                <a:srgbClr val="70AD47">
                  <a:lumMod val="50000"/>
                </a:srgbClr>
              </a:solidFill>
              <a:latin typeface="Calibri" panose="020F0502020204030204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8CF6A2E-C3E0-462D-2A89-83B3F919F4D6}"/>
              </a:ext>
            </a:extLst>
          </p:cNvPr>
          <p:cNvSpPr txBox="1"/>
          <p:nvPr/>
        </p:nvSpPr>
        <p:spPr>
          <a:xfrm>
            <a:off x="8962911" y="256423"/>
            <a:ext cx="1486588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42900"/>
            <a:r>
              <a:rPr lang="en-US" sz="1500" b="1" dirty="0">
                <a:solidFill>
                  <a:srgbClr val="FF0000"/>
                </a:solidFill>
                <a:latin typeface="Calibri" panose="020F0502020204030204"/>
              </a:rPr>
              <a:t>Significant 32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E00CF7E-B111-F2D7-D602-FDA8C7E906D1}"/>
              </a:ext>
            </a:extLst>
          </p:cNvPr>
          <p:cNvSpPr txBox="1"/>
          <p:nvPr/>
        </p:nvSpPr>
        <p:spPr>
          <a:xfrm>
            <a:off x="8848437" y="521839"/>
            <a:ext cx="1601062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42900"/>
            <a:r>
              <a:rPr lang="en-US" sz="1500" b="1" dirty="0">
                <a:solidFill>
                  <a:srgbClr val="70AD47">
                    <a:lumMod val="50000"/>
                  </a:srgbClr>
                </a:solidFill>
                <a:latin typeface="Calibri" panose="020F0502020204030204"/>
              </a:rPr>
              <a:t>Un-Significant 70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C64CE18-24E6-7231-289E-19BCC4947388}"/>
              </a:ext>
            </a:extLst>
          </p:cNvPr>
          <p:cNvSpPr txBox="1"/>
          <p:nvPr/>
        </p:nvSpPr>
        <p:spPr>
          <a:xfrm flipH="1">
            <a:off x="517235" y="159569"/>
            <a:ext cx="30018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22010042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6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1_Office Theme</vt:lpstr>
      <vt:lpstr>Supplementary Figure 1:  One-way analysis of variance of identified metabolites (n=394) among all phenotypic groups (planktonic cells under shaking (PLSH), planktonic cells under static conditions (PLST), and biofilm cells). Green and red-colored dots, represent metabolites with nonsignificant or significant difference among the three groups, respectively.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One-way ANOVA of identified metabolites among all groups</dc:title>
  <dc:creator>Abdelhamid, Ahmed</dc:creator>
  <cp:lastModifiedBy>Adaeze Catherine Awogu</cp:lastModifiedBy>
  <cp:revision>3</cp:revision>
  <dcterms:created xsi:type="dcterms:W3CDTF">2023-10-26T20:15:57Z</dcterms:created>
  <dcterms:modified xsi:type="dcterms:W3CDTF">2024-02-07T10:43:54Z</dcterms:modified>
</cp:coreProperties>
</file>